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C6FE818-BCDD-49DC-9CD9-700C4FB313AF}" v="6" dt="2021-05-26T04:10:41.07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50" d="100"/>
          <a:sy n="50" d="100"/>
        </p:scale>
        <p:origin x="29" y="10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lison Graper" userId="b6ea7f156f7cc013" providerId="LiveId" clId="{9C6FE818-BCDD-49DC-9CD9-700C4FB313AF}"/>
    <pc:docChg chg="undo custSel addSld delSld modSld">
      <pc:chgData name="Allison Graper" userId="b6ea7f156f7cc013" providerId="LiveId" clId="{9C6FE818-BCDD-49DC-9CD9-700C4FB313AF}" dt="2021-05-26T04:15:06.234" v="70" actId="732"/>
      <pc:docMkLst>
        <pc:docMk/>
      </pc:docMkLst>
      <pc:sldChg chg="del">
        <pc:chgData name="Allison Graper" userId="b6ea7f156f7cc013" providerId="LiveId" clId="{9C6FE818-BCDD-49DC-9CD9-700C4FB313AF}" dt="2021-05-26T03:47:49.472" v="25" actId="2696"/>
        <pc:sldMkLst>
          <pc:docMk/>
          <pc:sldMk cId="2607234594" sldId="259"/>
        </pc:sldMkLst>
      </pc:sldChg>
      <pc:sldChg chg="addSp delSp modSp mod">
        <pc:chgData name="Allison Graper" userId="b6ea7f156f7cc013" providerId="LiveId" clId="{9C6FE818-BCDD-49DC-9CD9-700C4FB313AF}" dt="2021-05-26T04:10:08.474" v="62" actId="478"/>
        <pc:sldMkLst>
          <pc:docMk/>
          <pc:sldMk cId="3458505256" sldId="260"/>
        </pc:sldMkLst>
        <pc:spChg chg="mod">
          <ac:chgData name="Allison Graper" userId="b6ea7f156f7cc013" providerId="LiveId" clId="{9C6FE818-BCDD-49DC-9CD9-700C4FB313AF}" dt="2021-05-26T03:35:14.218" v="1" actId="20577"/>
          <ac:spMkLst>
            <pc:docMk/>
            <pc:sldMk cId="3458505256" sldId="260"/>
            <ac:spMk id="2" creationId="{8BE7CFC0-0FD2-42E8-8F04-CE3A59BE80E7}"/>
          </ac:spMkLst>
        </pc:spChg>
        <pc:spChg chg="add del mod">
          <ac:chgData name="Allison Graper" userId="b6ea7f156f7cc013" providerId="LiveId" clId="{9C6FE818-BCDD-49DC-9CD9-700C4FB313AF}" dt="2021-05-26T04:10:08.474" v="62" actId="478"/>
          <ac:spMkLst>
            <pc:docMk/>
            <pc:sldMk cId="3458505256" sldId="260"/>
            <ac:spMk id="3" creationId="{06346BCA-D9ED-4BFA-980B-3165D5E1F787}"/>
          </ac:spMkLst>
        </pc:spChg>
      </pc:sldChg>
      <pc:sldChg chg="addSp delSp modSp new mod">
        <pc:chgData name="Allison Graper" userId="b6ea7f156f7cc013" providerId="LiveId" clId="{9C6FE818-BCDD-49DC-9CD9-700C4FB313AF}" dt="2021-05-26T04:15:06.234" v="70" actId="732"/>
        <pc:sldMkLst>
          <pc:docMk/>
          <pc:sldMk cId="3229393897" sldId="261"/>
        </pc:sldMkLst>
        <pc:spChg chg="add mod">
          <ac:chgData name="Allison Graper" userId="b6ea7f156f7cc013" providerId="LiveId" clId="{9C6FE818-BCDD-49DC-9CD9-700C4FB313AF}" dt="2021-05-26T04:10:39.591" v="64" actId="1076"/>
          <ac:spMkLst>
            <pc:docMk/>
            <pc:sldMk cId="3229393897" sldId="261"/>
            <ac:spMk id="5" creationId="{D68840F3-2541-4279-B06F-8F2AA7D8C1D6}"/>
          </ac:spMkLst>
        </pc:spChg>
        <pc:spChg chg="add mod">
          <ac:chgData name="Allison Graper" userId="b6ea7f156f7cc013" providerId="LiveId" clId="{9C6FE818-BCDD-49DC-9CD9-700C4FB313AF}" dt="2021-05-26T04:10:48.875" v="68" actId="20577"/>
          <ac:spMkLst>
            <pc:docMk/>
            <pc:sldMk cId="3229393897" sldId="261"/>
            <ac:spMk id="6" creationId="{A7F1BDCC-35B8-471A-A07A-657CBB83B902}"/>
          </ac:spMkLst>
        </pc:spChg>
        <pc:picChg chg="add mod modCrop">
          <ac:chgData name="Allison Graper" userId="b6ea7f156f7cc013" providerId="LiveId" clId="{9C6FE818-BCDD-49DC-9CD9-700C4FB313AF}" dt="2021-05-26T04:15:06.234" v="70" actId="732"/>
          <ac:picMkLst>
            <pc:docMk/>
            <pc:sldMk cId="3229393897" sldId="261"/>
            <ac:picMk id="2" creationId="{57537BF8-9B59-4249-A819-2D57BDEAB299}"/>
          </ac:picMkLst>
        </pc:picChg>
        <pc:picChg chg="add del mod modCrop">
          <ac:chgData name="Allison Graper" userId="b6ea7f156f7cc013" providerId="LiveId" clId="{9C6FE818-BCDD-49DC-9CD9-700C4FB313AF}" dt="2021-05-26T03:47:28.576" v="20" actId="478"/>
          <ac:picMkLst>
            <pc:docMk/>
            <pc:sldMk cId="3229393897" sldId="261"/>
            <ac:picMk id="3" creationId="{90D6114B-D703-43C7-8A13-7E2FC7CC8783}"/>
          </ac:picMkLst>
        </pc:picChg>
        <pc:picChg chg="add mod">
          <ac:chgData name="Allison Graper" userId="b6ea7f156f7cc013" providerId="LiveId" clId="{9C6FE818-BCDD-49DC-9CD9-700C4FB313AF}" dt="2021-05-26T03:48:34.665" v="37" actId="1076"/>
          <ac:picMkLst>
            <pc:docMk/>
            <pc:sldMk cId="3229393897" sldId="261"/>
            <ac:picMk id="4" creationId="{CBAC4A20-E617-43AC-BB1E-6CF4866CE09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8D8959-354A-42F4-BFBC-EB4841B43C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C86347-84E3-4B65-99C5-EE56893148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AE7E61-B3DF-4656-94B7-0A7BAF2C4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49527C-EF94-43F8-A4F4-A147BC7EC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E8CC49-CAA0-46F1-B813-C0C10CC94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80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A74275-B39A-41EF-93CD-E72B0D110C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228A30-A84C-476D-A2F6-93061F9A1C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181FC7-50CB-4BDB-A7FF-596F76739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B48DD-3975-48E9-8C0E-3FB1554A2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1A2E25-4E45-4E07-8A01-82B7378E5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072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485AC9-BEB1-4A46-AA26-35D587CD3F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6AA0B2-951F-48FE-A4C5-4A1123FBFD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1F0639-53E8-450D-B551-486AC68E2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EB2029-5B22-432E-8C33-6F4CEDFFD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49ABDA-E284-4B66-AFCA-47AAED01F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082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1EC204-7C07-4110-8002-911D021260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092145-459D-4F71-A9B1-FF459FFD91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BBB3AA-97AC-4B74-B999-83A9EA513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5ED373-7071-42B2-91B4-889BE3C6D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995001-4150-4A9E-8F41-0F258F644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345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6F4B49-BF17-4243-97EA-DEBE982DA2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110E06-2C47-4694-AFA5-4B0FD46FDA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6F380B-B5D2-4A6A-BA79-3D93279D0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703B05-FBB7-4B10-A4A3-A013BC3F7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19AEEB-69AB-440A-A95A-407167D27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978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BA683-6ED1-4973-9729-D8C133B798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082793-FC4D-42CF-BBE0-EEF295A029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4A55A7-6471-4AB8-9DA5-CC8EBA2B0D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02678A-2AF6-4954-BA51-61A82A077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33751E-F43A-40D6-80A6-0E7DA0CA8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A55411-A056-4BCF-AA2E-3136C60FD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37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ADA988-B0FE-4005-B16D-AB63F4078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283D7D-7885-45BC-9F13-B29622503F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69F170-3D93-4612-94AE-A79532AA6B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C2BFC3-C819-4F73-B3EB-F2116EF55E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1B9DBC-CFBC-46D5-97D8-4E899A4055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C69D24-6A27-4CFD-8C9B-3154E5BCE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B32B6E-742E-423A-A8B1-FF8CAED68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3006942-9144-4FE3-8216-8105E43D0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288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C1C4C-FD8F-45BD-9E6D-D13222515E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5939220-F1D5-4486-8FB7-95419F9A8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DE7C3B-6CD4-4A89-9BFB-B55200919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FA650A-30EB-473A-A857-8942734F9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135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05C800-EBF8-432E-A9E5-C334347B7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126D9B-26D3-40BE-88A0-CEC80402E6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D6687E-C6FA-41C6-9C1C-E9BC3A716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79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225C34-532B-4EE8-955A-5DED9011C0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5F6C58-9C38-42AE-B2B4-4D48BE1F43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776C12-43CD-474A-BECF-63C69ABB53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B23884-DED8-4DAC-B486-54429E93A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8F1FC4-0E42-4733-A6BD-185EDFEC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EB4AFE-E404-4184-A00E-6CE8B6BB5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11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1F289D-455F-4BC3-921E-2C75D1578B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3A9D31-6FE7-410E-9492-4F6FA01EBB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79451A-0D0F-4851-BE15-13469B0306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9B7B77-60C5-49F7-ADC9-46A6A2F46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572996-F240-4ACD-B816-F8499A00B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AE8C0F-964B-417E-B5F7-9467F5228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664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721909F-AB3C-4757-BE50-AEBED7C40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28A075-A306-4AD8-8983-5A2C767256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55762A-B6BD-49A7-9D4D-FF10A0EF5C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CD8AC-4106-4BCD-8154-AB5C1EC10F64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0BBE84-409A-4A1D-8023-E3964E7BCF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EF6D4D-EFBB-4786-90F4-02BFD9A40F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440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3">
            <a:extLst>
              <a:ext uri="{FF2B5EF4-FFF2-40B4-BE49-F238E27FC236}">
                <a16:creationId xmlns:a16="http://schemas.microsoft.com/office/drawing/2014/main" id="{8BE7CFC0-0FD2-42E8-8F04-CE3A59BE80E7}"/>
              </a:ext>
            </a:extLst>
          </p:cNvPr>
          <p:cNvSpPr txBox="1">
            <a:spLocks/>
          </p:cNvSpPr>
          <p:nvPr/>
        </p:nvSpPr>
        <p:spPr>
          <a:xfrm>
            <a:off x="838200" y="457200"/>
            <a:ext cx="105156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bility in ITS1 and ITS2 sequences of historic (herbaria) and extant (fresh)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lari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es (Graper, Noyszewski, Anderson, Smith) 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3458505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7537BF8-9B59-4249-A819-2D57BDEAB29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138" t="6069" r="2925" b="12439"/>
          <a:stretch/>
        </p:blipFill>
        <p:spPr>
          <a:xfrm>
            <a:off x="1950720" y="574701"/>
            <a:ext cx="3307047" cy="570859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BAC4A20-E617-43AC-BB1E-6CF4866CE0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53760" y="574701"/>
            <a:ext cx="4287520" cy="570859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68840F3-2541-4279-B06F-8F2AA7D8C1D6}"/>
              </a:ext>
            </a:extLst>
          </p:cNvPr>
          <p:cNvSpPr txBox="1"/>
          <p:nvPr/>
        </p:nvSpPr>
        <p:spPr>
          <a:xfrm>
            <a:off x="3460377" y="205369"/>
            <a:ext cx="287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F1BDCC-35B8-471A-A07A-657CBB83B902}"/>
              </a:ext>
            </a:extLst>
          </p:cNvPr>
          <p:cNvSpPr txBox="1"/>
          <p:nvPr/>
        </p:nvSpPr>
        <p:spPr>
          <a:xfrm>
            <a:off x="7953654" y="205369"/>
            <a:ext cx="287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29393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1</TotalTime>
  <Words>32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Graper</dc:creator>
  <cp:lastModifiedBy>Alli Graper</cp:lastModifiedBy>
  <cp:revision>6</cp:revision>
  <dcterms:created xsi:type="dcterms:W3CDTF">2021-01-22T20:43:25Z</dcterms:created>
  <dcterms:modified xsi:type="dcterms:W3CDTF">2021-05-26T04:15:15Z</dcterms:modified>
</cp:coreProperties>
</file>